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  <p:sldId id="260" r:id="rId5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336" y="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C41593-28A9-44B9-B8A6-08A8843BBB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E388D28-5371-48BD-B92F-0B430588DD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596AEE-58FD-4648-9E88-240249839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2C2699-A674-4C5C-8A40-D8CA5E1CC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3EC568-4F77-4197-B450-ACB5A19BD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81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13A996-0055-46F1-8785-FC12CFFD3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B83A320-3C0C-4A56-8781-D28F1BE14A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03E253-7A87-4090-9896-1D673E9A3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96303C-D8A9-4B12-AFBE-ECD0DFB5B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88B1D4-F0D3-4374-88AF-6AE80359D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962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DB69347-F51A-4B13-8B52-39329385F5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6D6C6EC-70B8-40AE-8FF8-471DA55D05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305B95-A1C9-40F6-8709-6AA60592B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1109CF-31CF-4193-BF05-E16E2ED02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308291-AA02-4808-A055-0C0FDC2A8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259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CCB72D-AB31-4DC6-B5B2-9BFF1832A8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A68766-A0D1-498A-A4A6-B3285846C2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DA0A66-5B73-4CD2-A2BE-D65CDD1D9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7934AB-55D2-44B6-8F7F-001864019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00A262-7E95-4136-B33A-506DCD304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57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26EC33-DC92-4BE0-AB34-DA50088B0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FDF447D-E00E-40C1-BC3B-B6BE1E8384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63058B-6C65-4D81-BD6C-2149B8CE5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31D32B-40B1-45CB-8155-4CDDDB6E4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3568B8-4D7E-4491-90A9-171C8B1CF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290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2F9CF9-928C-4131-AE67-E087427406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4C15E5-F450-4A72-8ED2-67882ED663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656443-D949-45B8-A838-831AD9A0F8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E72E61-099B-4F09-A579-03968C27F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C627D2-B007-413D-9F80-CA0928646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077FAB-08FE-4501-83F8-79027C453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19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AA06FF-BDF0-4C1D-9123-1E8A2B14E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6229F4-A8BB-44BE-A224-77F73C61D9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E2F0A62-8A71-4545-BEE0-3DF477E408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2577DC2-2BBB-4328-946A-694CEDA01B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FA6A18E-D603-4A11-ACAC-485C964713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09EFC88-8AB6-4269-B70D-650C635A3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85BB96F-6F5F-4A7B-8CFE-09AEF2AB7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719CCE-269F-4BC8-BE70-C44E57FA4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21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9A5A30-FF6A-4241-AA25-4D8DE507A6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23C23B8-A819-4DA1-818C-2AD701B5E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C2B581F-6B82-4E64-9605-EBE638C0B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13022E3-103B-4DE9-B6DE-264EBD91A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704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B2DDEB8-1D2B-4708-A41C-5EC67B015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B84566E-EDE7-461D-AB6B-715A33E82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788A3D8-0B76-47C5-AAA3-4A7015F92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344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310076-3FF0-40E7-8967-34B46032F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2171CB-F5D6-4FD7-9E4D-3D9B5B2339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08D4396-8990-4B12-BDDD-607A018DE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844A792-13B6-49D2-8D93-2DC043B5E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93DC94F-07C7-4BBA-AC14-5D57522E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0C357E-BF30-4BCC-96BC-5520F9275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619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0F01C4-5189-4CAA-90CE-9BEADD59B9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A37CAC2-F52B-4034-AE58-105BEBA574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4799B32-4EB4-48C4-A0CF-2A595ADCA8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2BCB90-81CC-4A75-9FF3-8B88EE2CF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C6F086-DADC-4D99-BE99-ABE3D804D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9FD6F82-FCB5-4499-A6F7-58A12C656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2881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65FCDD2-90CC-4BE3-922B-12212A47DD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B0D936-ACE7-4409-ACA5-60A9975FD5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536014-43D0-4473-957B-769C924365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28F28-5162-449C-ACEA-EE391EB69F13}" type="datetimeFigureOut">
              <a:rPr lang="zh-CN" altLang="en-US" smtClean="0"/>
              <a:pPr/>
              <a:t>2020/1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F1AD77-2F48-4C26-B393-7EDE5805F7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DDF477-6730-4AC2-A203-F67205DD96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1F6A7-6E65-4CC0-914E-B3E492425B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0587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8C3CFB-75B7-49E5-813F-B8C307A6C5C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3213" y="370673"/>
            <a:ext cx="7342296" cy="637260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91304" y="131885"/>
            <a:ext cx="1397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ure S1 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0981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79020A8-D745-4B9E-BE14-24334033B2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5241" y="473812"/>
            <a:ext cx="7994881" cy="562051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91304" y="131885"/>
            <a:ext cx="1283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ure S2 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3165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0B02C96-5F06-4B9E-85A8-F3143990200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585" y="559043"/>
            <a:ext cx="7295715" cy="594676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91304" y="131885"/>
            <a:ext cx="1283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ure S3 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54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>
            <a:extLst>
              <a:ext uri="{FF2B5EF4-FFF2-40B4-BE49-F238E27FC236}">
                <a16:creationId xmlns:a16="http://schemas.microsoft.com/office/drawing/2014/main" id="{1ED674A3-3A9C-4439-8141-E13269887A64}"/>
              </a:ext>
            </a:extLst>
          </p:cNvPr>
          <p:cNvSpPr txBox="1"/>
          <p:nvPr/>
        </p:nvSpPr>
        <p:spPr>
          <a:xfrm>
            <a:off x="791304" y="131885"/>
            <a:ext cx="1283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igure S4 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F911EF13-A9B2-4D88-985E-2E9814DE5817}"/>
              </a:ext>
            </a:extLst>
          </p:cNvPr>
          <p:cNvGrpSpPr/>
          <p:nvPr/>
        </p:nvGrpSpPr>
        <p:grpSpPr>
          <a:xfrm>
            <a:off x="1807029" y="555173"/>
            <a:ext cx="9157063" cy="5972984"/>
            <a:chOff x="1807029" y="555173"/>
            <a:chExt cx="9157063" cy="5972984"/>
          </a:xfrm>
        </p:grpSpPr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id="{7CF80958-0B02-44A4-9190-E45A923D22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66527" y="5048936"/>
              <a:ext cx="1881866" cy="1188585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6DC5A785-3D68-43C6-9F7A-7D6DF26D4A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16011" y="5050978"/>
              <a:ext cx="1857270" cy="1197429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74E179DC-E943-47F2-B3C7-C5E2C792C5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25501" y="2993577"/>
              <a:ext cx="1836899" cy="1240972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D170D1E9-AEF6-4D23-BC6B-18B53EED52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761558" y="870859"/>
              <a:ext cx="1830244" cy="1273627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7558DDE-DD32-4A91-B69C-619C9692026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45459" y="892629"/>
              <a:ext cx="1814769" cy="1273629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AEB48FDE-164F-4C64-8E4F-66671469D1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25500" y="881744"/>
              <a:ext cx="1826015" cy="1284513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AACD980-A01A-4407-A712-4487E3C969A1}"/>
                </a:ext>
              </a:extLst>
            </p:cNvPr>
            <p:cNvSpPr txBox="1"/>
            <p:nvPr/>
          </p:nvSpPr>
          <p:spPr>
            <a:xfrm>
              <a:off x="2912291" y="3890561"/>
              <a:ext cx="10718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0.058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A514ABA-071F-4C05-B769-882CDD80E311}"/>
                </a:ext>
              </a:extLst>
            </p:cNvPr>
            <p:cNvSpPr txBox="1"/>
            <p:nvPr/>
          </p:nvSpPr>
          <p:spPr>
            <a:xfrm>
              <a:off x="2177869" y="3025504"/>
              <a:ext cx="7852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132Q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CF0CDF4-ACEE-4097-BF3F-12A4ED625A1C}"/>
                </a:ext>
              </a:extLst>
            </p:cNvPr>
            <p:cNvSpPr txBox="1"/>
            <p:nvPr/>
          </p:nvSpPr>
          <p:spPr>
            <a:xfrm>
              <a:off x="2225765" y="903515"/>
              <a:ext cx="8708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PVR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0D0BD306-59B3-4C08-9EA9-3E64D64B7435}"/>
                </a:ext>
              </a:extLst>
            </p:cNvPr>
            <p:cNvSpPr txBox="1"/>
            <p:nvPr/>
          </p:nvSpPr>
          <p:spPr>
            <a:xfrm>
              <a:off x="2900681" y="1836058"/>
              <a:ext cx="10617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1.146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B421F0F-D8E4-47DB-8269-C25539FEA171}"/>
                </a:ext>
              </a:extLst>
            </p:cNvPr>
            <p:cNvSpPr txBox="1"/>
            <p:nvPr/>
          </p:nvSpPr>
          <p:spPr>
            <a:xfrm>
              <a:off x="4060372" y="566059"/>
              <a:ext cx="457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089355F-9A45-4F1F-A65D-80E4B113B8D0}"/>
                </a:ext>
              </a:extLst>
            </p:cNvPr>
            <p:cNvSpPr txBox="1"/>
            <p:nvPr/>
          </p:nvSpPr>
          <p:spPr>
            <a:xfrm>
              <a:off x="8425545" y="598715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2A90B677-2092-47AB-8E52-09FBCB73A18D}"/>
                </a:ext>
              </a:extLst>
            </p:cNvPr>
            <p:cNvSpPr txBox="1"/>
            <p:nvPr/>
          </p:nvSpPr>
          <p:spPr>
            <a:xfrm>
              <a:off x="6248402" y="566059"/>
              <a:ext cx="4027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1E56C21-6885-4F38-820E-B76293E6C716}"/>
                </a:ext>
              </a:extLst>
            </p:cNvPr>
            <p:cNvSpPr txBox="1"/>
            <p:nvPr/>
          </p:nvSpPr>
          <p:spPr>
            <a:xfrm>
              <a:off x="1807030" y="2503717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C04FB55-9450-4313-8DE3-3FC738548D95}"/>
                </a:ext>
              </a:extLst>
            </p:cNvPr>
            <p:cNvSpPr txBox="1"/>
            <p:nvPr/>
          </p:nvSpPr>
          <p:spPr>
            <a:xfrm>
              <a:off x="4071259" y="2601692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AED1289-00AC-4B85-8095-83DD0959DE4C}"/>
                </a:ext>
              </a:extLst>
            </p:cNvPr>
            <p:cNvSpPr txBox="1"/>
            <p:nvPr/>
          </p:nvSpPr>
          <p:spPr>
            <a:xfrm>
              <a:off x="6259287" y="2547262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1433AC5-911C-49E3-B665-80B828FEC213}"/>
                </a:ext>
              </a:extLst>
            </p:cNvPr>
            <p:cNvSpPr txBox="1"/>
            <p:nvPr/>
          </p:nvSpPr>
          <p:spPr>
            <a:xfrm>
              <a:off x="8458202" y="2634347"/>
              <a:ext cx="53339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DC6A8C8C-9C2F-4A33-8C13-0652A8869394}"/>
                </a:ext>
              </a:extLst>
            </p:cNvPr>
            <p:cNvSpPr txBox="1"/>
            <p:nvPr/>
          </p:nvSpPr>
          <p:spPr>
            <a:xfrm>
              <a:off x="1828802" y="4680856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4EC80602-F39B-4144-972F-43F1FFA062C2}"/>
                </a:ext>
              </a:extLst>
            </p:cNvPr>
            <p:cNvSpPr txBox="1"/>
            <p:nvPr/>
          </p:nvSpPr>
          <p:spPr>
            <a:xfrm>
              <a:off x="2160449" y="2217058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D01D243C-C575-4B64-BEA6-2AB6A0BFCA7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318405" y="892633"/>
              <a:ext cx="1832026" cy="1284514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99F8DAF0-F132-40E4-A5E6-69F3BA45A660}"/>
                </a:ext>
              </a:extLst>
            </p:cNvPr>
            <p:cNvSpPr txBox="1"/>
            <p:nvPr/>
          </p:nvSpPr>
          <p:spPr>
            <a:xfrm rot="16200000">
              <a:off x="1428682" y="1320835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A837C93-EA6D-4E97-B409-DA0F52C58796}"/>
                </a:ext>
              </a:extLst>
            </p:cNvPr>
            <p:cNvSpPr txBox="1"/>
            <p:nvPr/>
          </p:nvSpPr>
          <p:spPr>
            <a:xfrm rot="16200000">
              <a:off x="3616718" y="1288176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A5844E94-94D9-4D29-9896-5860622A5F34}"/>
                </a:ext>
              </a:extLst>
            </p:cNvPr>
            <p:cNvSpPr txBox="1"/>
            <p:nvPr/>
          </p:nvSpPr>
          <p:spPr>
            <a:xfrm>
              <a:off x="4402911" y="2217054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EFC1BCD-578D-4267-9E6B-562570768BE3}"/>
                </a:ext>
              </a:extLst>
            </p:cNvPr>
            <p:cNvSpPr txBox="1"/>
            <p:nvPr/>
          </p:nvSpPr>
          <p:spPr>
            <a:xfrm>
              <a:off x="5553890" y="955766"/>
              <a:ext cx="5965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72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F39160D-ADCC-4EE8-95F0-448931156825}"/>
                </a:ext>
              </a:extLst>
            </p:cNvPr>
            <p:cNvSpPr txBox="1"/>
            <p:nvPr/>
          </p:nvSpPr>
          <p:spPr>
            <a:xfrm>
              <a:off x="4363720" y="1811384"/>
              <a:ext cx="10355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0.328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6BF9D52-FF19-46E1-AE49-19797CC98A2E}"/>
                </a:ext>
              </a:extLst>
            </p:cNvPr>
            <p:cNvSpPr txBox="1"/>
            <p:nvPr/>
          </p:nvSpPr>
          <p:spPr>
            <a:xfrm>
              <a:off x="1807029" y="555173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5B81B30E-F840-404A-B9AB-4397B5C29E58}"/>
                </a:ext>
              </a:extLst>
            </p:cNvPr>
            <p:cNvSpPr txBox="1"/>
            <p:nvPr/>
          </p:nvSpPr>
          <p:spPr>
            <a:xfrm>
              <a:off x="6612713" y="2227940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B075891-F7A7-4406-A635-CBB792B96B6D}"/>
                </a:ext>
              </a:extLst>
            </p:cNvPr>
            <p:cNvSpPr txBox="1"/>
            <p:nvPr/>
          </p:nvSpPr>
          <p:spPr>
            <a:xfrm rot="16200000">
              <a:off x="5826518" y="1288176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B5E2D05-CD35-4A3C-A2CB-D795EEE1FE1E}"/>
                </a:ext>
              </a:extLst>
            </p:cNvPr>
            <p:cNvSpPr txBox="1"/>
            <p:nvPr/>
          </p:nvSpPr>
          <p:spPr>
            <a:xfrm>
              <a:off x="6550296" y="933995"/>
              <a:ext cx="8708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72R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3120340D-31F8-4F40-8D04-913E06345B6F}"/>
                </a:ext>
              </a:extLst>
            </p:cNvPr>
            <p:cNvSpPr txBox="1"/>
            <p:nvPr/>
          </p:nvSpPr>
          <p:spPr>
            <a:xfrm>
              <a:off x="9554754" y="1783082"/>
              <a:ext cx="12874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0.016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BB6A9FF-D8E8-45E6-BB3C-B5C54E8FF7A2}"/>
                </a:ext>
              </a:extLst>
            </p:cNvPr>
            <p:cNvSpPr txBox="1"/>
            <p:nvPr/>
          </p:nvSpPr>
          <p:spPr>
            <a:xfrm>
              <a:off x="8866059" y="2227940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14E62854-E380-4F8D-9ECF-E6CB7F03A0D6}"/>
                </a:ext>
              </a:extLst>
            </p:cNvPr>
            <p:cNvSpPr txBox="1"/>
            <p:nvPr/>
          </p:nvSpPr>
          <p:spPr>
            <a:xfrm rot="16200000">
              <a:off x="8058089" y="1277286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C8E07B9-AF30-4E99-B26E-9024C9AF0945}"/>
                </a:ext>
              </a:extLst>
            </p:cNvPr>
            <p:cNvSpPr txBox="1"/>
            <p:nvPr/>
          </p:nvSpPr>
          <p:spPr>
            <a:xfrm>
              <a:off x="8782595" y="944154"/>
              <a:ext cx="8164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131V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57B26B8-2902-4819-9DD4-AE0B64DE502F}"/>
                </a:ext>
              </a:extLst>
            </p:cNvPr>
            <p:cNvSpPr txBox="1"/>
            <p:nvPr/>
          </p:nvSpPr>
          <p:spPr>
            <a:xfrm>
              <a:off x="7387771" y="1815012"/>
              <a:ext cx="11030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0.549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BAABA4C6-2C2C-45D7-BF03-7634EF71E404}"/>
                </a:ext>
              </a:extLst>
            </p:cNvPr>
            <p:cNvSpPr txBox="1"/>
            <p:nvPr/>
          </p:nvSpPr>
          <p:spPr>
            <a:xfrm rot="16200000">
              <a:off x="1428678" y="3432664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B4411BB-A705-4189-85DD-9E5864C49CEA}"/>
                </a:ext>
              </a:extLst>
            </p:cNvPr>
            <p:cNvSpPr txBox="1"/>
            <p:nvPr/>
          </p:nvSpPr>
          <p:spPr>
            <a:xfrm>
              <a:off x="2160445" y="4285346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9CC689C-D51B-4919-B68D-8DE1D615A80A}"/>
                </a:ext>
              </a:extLst>
            </p:cNvPr>
            <p:cNvSpPr txBox="1"/>
            <p:nvPr/>
          </p:nvSpPr>
          <p:spPr>
            <a:xfrm rot="16200000">
              <a:off x="3627587" y="3432660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56707EDA-CFFE-4F9B-9957-EBA01E482DC7}"/>
                </a:ext>
              </a:extLst>
            </p:cNvPr>
            <p:cNvSpPr txBox="1"/>
            <p:nvPr/>
          </p:nvSpPr>
          <p:spPr>
            <a:xfrm>
              <a:off x="4359354" y="4285342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307FD79E-3545-4720-8BA1-B305C32615E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299857" y="2960918"/>
              <a:ext cx="1861458" cy="1240971"/>
            </a:xfrm>
            <a:prstGeom prst="rect">
              <a:avLst/>
            </a:prstGeom>
          </p:spPr>
        </p:pic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C415102B-23A9-419C-802C-AD14590C9BB6}"/>
                </a:ext>
              </a:extLst>
            </p:cNvPr>
            <p:cNvSpPr txBox="1"/>
            <p:nvPr/>
          </p:nvSpPr>
          <p:spPr>
            <a:xfrm>
              <a:off x="4323808" y="2983417"/>
              <a:ext cx="7837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74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4E98B03D-921C-4540-84A2-3BD7E7E75FC6}"/>
                </a:ext>
              </a:extLst>
            </p:cNvPr>
            <p:cNvSpPr txBox="1"/>
            <p:nvPr/>
          </p:nvSpPr>
          <p:spPr>
            <a:xfrm>
              <a:off x="5148217" y="3897090"/>
              <a:ext cx="10566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8.801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DF84A78A-60DA-4073-9CCB-C1F49494E31F}"/>
                </a:ext>
              </a:extLst>
            </p:cNvPr>
            <p:cNvSpPr txBox="1"/>
            <p:nvPr/>
          </p:nvSpPr>
          <p:spPr>
            <a:xfrm rot="16200000">
              <a:off x="5848276" y="3443542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F42BBA20-258F-42BD-A76E-716574A4D453}"/>
                </a:ext>
              </a:extLst>
            </p:cNvPr>
            <p:cNvSpPr txBox="1"/>
            <p:nvPr/>
          </p:nvSpPr>
          <p:spPr>
            <a:xfrm>
              <a:off x="6580043" y="4285338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4CF865EB-8DFD-40B7-B080-ECE5005694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530070" y="2987455"/>
              <a:ext cx="1873703" cy="1214436"/>
            </a:xfrm>
            <a:prstGeom prst="rect">
              <a:avLst/>
            </a:prstGeom>
          </p:spPr>
        </p:pic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CC3B063C-C0D9-46E5-8E72-F8443DBBAECD}"/>
                </a:ext>
              </a:extLst>
            </p:cNvPr>
            <p:cNvSpPr txBox="1"/>
            <p:nvPr/>
          </p:nvSpPr>
          <p:spPr>
            <a:xfrm>
              <a:off x="7385593" y="3858630"/>
              <a:ext cx="13360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5.141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91653D01-C55C-41AF-9CCD-81811B15E2E2}"/>
                </a:ext>
              </a:extLst>
            </p:cNvPr>
            <p:cNvSpPr txBox="1"/>
            <p:nvPr/>
          </p:nvSpPr>
          <p:spPr>
            <a:xfrm>
              <a:off x="6567714" y="2981965"/>
              <a:ext cx="6059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87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D7259BAB-5673-4E9A-8755-22EFF963F7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817429" y="2950030"/>
              <a:ext cx="1872343" cy="1262752"/>
            </a:xfrm>
            <a:prstGeom prst="rect">
              <a:avLst/>
            </a:prstGeom>
          </p:spPr>
        </p:pic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2CD674BD-D290-46C9-9347-E0BFEFAAA733}"/>
                </a:ext>
              </a:extLst>
            </p:cNvPr>
            <p:cNvSpPr txBox="1"/>
            <p:nvPr/>
          </p:nvSpPr>
          <p:spPr>
            <a:xfrm rot="16200000">
              <a:off x="8123393" y="3421780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B1BC426B-C4FB-49EA-B20A-3B1295C1135A}"/>
                </a:ext>
              </a:extLst>
            </p:cNvPr>
            <p:cNvSpPr txBox="1"/>
            <p:nvPr/>
          </p:nvSpPr>
          <p:spPr>
            <a:xfrm>
              <a:off x="8855160" y="4318006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861E1DC2-FEC7-4A70-93DE-6CB33CA5414A}"/>
                </a:ext>
              </a:extLst>
            </p:cNvPr>
            <p:cNvSpPr txBox="1"/>
            <p:nvPr/>
          </p:nvSpPr>
          <p:spPr>
            <a:xfrm>
              <a:off x="9628051" y="3893464"/>
              <a:ext cx="13360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21.372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BD9A5622-AAEA-4A61-8A2A-52B569F6789D}"/>
                </a:ext>
              </a:extLst>
            </p:cNvPr>
            <p:cNvSpPr txBox="1"/>
            <p:nvPr/>
          </p:nvSpPr>
          <p:spPr>
            <a:xfrm>
              <a:off x="8851538" y="3037845"/>
              <a:ext cx="86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131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4F9C08A-01E1-4DCB-B591-8213FED71D59}"/>
                </a:ext>
              </a:extLst>
            </p:cNvPr>
            <p:cNvSpPr txBox="1"/>
            <p:nvPr/>
          </p:nvSpPr>
          <p:spPr>
            <a:xfrm>
              <a:off x="4103917" y="4659091"/>
              <a:ext cx="6531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93AB3803-9F7E-4ADF-A9A2-8948AED3CDA5}"/>
                </a:ext>
              </a:extLst>
            </p:cNvPr>
            <p:cNvSpPr txBox="1"/>
            <p:nvPr/>
          </p:nvSpPr>
          <p:spPr>
            <a:xfrm>
              <a:off x="2108195" y="5084360"/>
              <a:ext cx="8665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132R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41A510DF-5CEE-4F5A-9A7B-9ADC441BA2C9}"/>
                </a:ext>
              </a:extLst>
            </p:cNvPr>
            <p:cNvSpPr txBox="1"/>
            <p:nvPr/>
          </p:nvSpPr>
          <p:spPr>
            <a:xfrm>
              <a:off x="2913737" y="5929819"/>
              <a:ext cx="10922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2.552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5C1EA89D-2CF0-4D15-B0F2-4E9E2498D0B6}"/>
                </a:ext>
              </a:extLst>
            </p:cNvPr>
            <p:cNvSpPr txBox="1"/>
            <p:nvPr/>
          </p:nvSpPr>
          <p:spPr>
            <a:xfrm rot="16200000">
              <a:off x="1417780" y="5435637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BF9B7DB4-F79C-4A7D-997E-E3B40F2CDB80}"/>
                </a:ext>
              </a:extLst>
            </p:cNvPr>
            <p:cNvSpPr txBox="1"/>
            <p:nvPr/>
          </p:nvSpPr>
          <p:spPr>
            <a:xfrm>
              <a:off x="2149547" y="6266547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6612DCA2-62AC-4A9F-824E-9518CBABDB69}"/>
                </a:ext>
              </a:extLst>
            </p:cNvPr>
            <p:cNvSpPr txBox="1"/>
            <p:nvPr/>
          </p:nvSpPr>
          <p:spPr>
            <a:xfrm>
              <a:off x="4423948" y="5907322"/>
              <a:ext cx="13360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=2.218 μ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6F449002-ACA2-4C87-B24A-A2710E6672E7}"/>
                </a:ext>
              </a:extLst>
            </p:cNvPr>
            <p:cNvSpPr txBox="1"/>
            <p:nvPr/>
          </p:nvSpPr>
          <p:spPr>
            <a:xfrm>
              <a:off x="5561143" y="5094520"/>
              <a:ext cx="8287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131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FD55BA58-2DDC-4BBC-97F1-2E5FF04E1786}"/>
                </a:ext>
              </a:extLst>
            </p:cNvPr>
            <p:cNvSpPr txBox="1"/>
            <p:nvPr/>
          </p:nvSpPr>
          <p:spPr>
            <a:xfrm rot="16200000">
              <a:off x="3671126" y="5435637"/>
              <a:ext cx="11174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Nor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[‰] 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DEB2F483-9351-460F-8F78-FF846F2BE0AD}"/>
                </a:ext>
              </a:extLst>
            </p:cNvPr>
            <p:cNvSpPr txBox="1"/>
            <p:nvPr/>
          </p:nvSpPr>
          <p:spPr>
            <a:xfrm>
              <a:off x="4402893" y="6266547"/>
              <a:ext cx="16822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is-TIGIT concentratio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8986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</TotalTime>
  <Words>118</Words>
  <Application>Microsoft Office PowerPoint</Application>
  <PresentationFormat>宽屏</PresentationFormat>
  <Paragraphs>5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晓文</dc:creator>
  <cp:lastModifiedBy>周 晓文</cp:lastModifiedBy>
  <cp:revision>60</cp:revision>
  <dcterms:created xsi:type="dcterms:W3CDTF">2020-07-21T10:04:24Z</dcterms:created>
  <dcterms:modified xsi:type="dcterms:W3CDTF">2020-12-11T13:56:42Z</dcterms:modified>
</cp:coreProperties>
</file>